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bookmarkIdSeed="3">
  <p:sldMasterIdLst>
    <p:sldMasterId id="2147483660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>
        <p:scale>
          <a:sx n="125" d="100"/>
          <a:sy n="125" d="100"/>
        </p:scale>
        <p:origin x="1038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F03474-4609-4844-87CC-ED52ECFF4BC5}" type="datetimeFigureOut">
              <a:rPr lang="zh-CN" altLang="en-US" smtClean="0"/>
              <a:t>2024/5/3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8F6CD1-4832-4717-8E3D-D928F46B3AC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4682916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F03474-4609-4844-87CC-ED52ECFF4BC5}" type="datetimeFigureOut">
              <a:rPr lang="zh-CN" altLang="en-US" smtClean="0"/>
              <a:t>2024/5/3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8F6CD1-4832-4717-8E3D-D928F46B3AC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2894454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F03474-4609-4844-87CC-ED52ECFF4BC5}" type="datetimeFigureOut">
              <a:rPr lang="zh-CN" altLang="en-US" smtClean="0"/>
              <a:t>2024/5/3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8F6CD1-4832-4717-8E3D-D928F46B3AC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9905949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F03474-4609-4844-87CC-ED52ECFF4BC5}" type="datetimeFigureOut">
              <a:rPr lang="zh-CN" altLang="en-US" smtClean="0"/>
              <a:t>2024/5/3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8F6CD1-4832-4717-8E3D-D928F46B3AC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8051050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F03474-4609-4844-87CC-ED52ECFF4BC5}" type="datetimeFigureOut">
              <a:rPr lang="zh-CN" altLang="en-US" smtClean="0"/>
              <a:t>2024/5/3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8F6CD1-4832-4717-8E3D-D928F46B3AC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3913985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F03474-4609-4844-87CC-ED52ECFF4BC5}" type="datetimeFigureOut">
              <a:rPr lang="zh-CN" altLang="en-US" smtClean="0"/>
              <a:t>2024/5/30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8F6CD1-4832-4717-8E3D-D928F46B3AC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9945852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F03474-4609-4844-87CC-ED52ECFF4BC5}" type="datetimeFigureOut">
              <a:rPr lang="zh-CN" altLang="en-US" smtClean="0"/>
              <a:t>2024/5/30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8F6CD1-4832-4717-8E3D-D928F46B3AC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2323202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F03474-4609-4844-87CC-ED52ECFF4BC5}" type="datetimeFigureOut">
              <a:rPr lang="zh-CN" altLang="en-US" smtClean="0"/>
              <a:t>2024/5/30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8F6CD1-4832-4717-8E3D-D928F46B3AC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4619409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F03474-4609-4844-87CC-ED52ECFF4BC5}" type="datetimeFigureOut">
              <a:rPr lang="zh-CN" altLang="en-US" smtClean="0"/>
              <a:t>2024/5/30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8F6CD1-4832-4717-8E3D-D928F46B3AC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9651562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F03474-4609-4844-87CC-ED52ECFF4BC5}" type="datetimeFigureOut">
              <a:rPr lang="zh-CN" altLang="en-US" smtClean="0"/>
              <a:t>2024/5/30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8F6CD1-4832-4717-8E3D-D928F46B3AC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2775588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F03474-4609-4844-87CC-ED52ECFF4BC5}" type="datetimeFigureOut">
              <a:rPr lang="zh-CN" altLang="en-US" smtClean="0"/>
              <a:t>2024/5/30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8F6CD1-4832-4717-8E3D-D928F46B3AC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437433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CF03474-4609-4844-87CC-ED52ECFF4BC5}" type="datetimeFigureOut">
              <a:rPr lang="zh-CN" altLang="en-US" smtClean="0"/>
              <a:t>2024/5/3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48F6CD1-4832-4717-8E3D-D928F46B3AC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9771070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2">
            <a:extLst>
              <a:ext uri="{FF2B5EF4-FFF2-40B4-BE49-F238E27FC236}">
                <a16:creationId xmlns:a16="http://schemas.microsoft.com/office/drawing/2014/main" id="{FB4F7E13-5835-CE54-9D4B-45B1281AFC44}"/>
              </a:ext>
            </a:extLst>
          </p:cNvPr>
          <p:cNvSpPr>
            <a:spLocks noChangeArrowheads="1"/>
          </p:cNvSpPr>
          <p:nvPr/>
        </p:nvSpPr>
        <p:spPr bwMode="auto">
          <a:xfrm>
            <a:off x="2070100" y="361434"/>
            <a:ext cx="184731" cy="36933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zh-CN" altLang="en-US"/>
          </a:p>
        </p:txBody>
      </p:sp>
      <p:pic>
        <p:nvPicPr>
          <p:cNvPr id="1025" name="图片 1">
            <a:extLst>
              <a:ext uri="{FF2B5EF4-FFF2-40B4-BE49-F238E27FC236}">
                <a16:creationId xmlns:a16="http://schemas.microsoft.com/office/drawing/2014/main" id="{6764FBD8-3C5E-FB94-0A36-9D6CD5A07AB6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464546" y="934721"/>
            <a:ext cx="6781844" cy="3713479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5" name="Rectangle 3">
            <a:extLst>
              <a:ext uri="{FF2B5EF4-FFF2-40B4-BE49-F238E27FC236}">
                <a16:creationId xmlns:a16="http://schemas.microsoft.com/office/drawing/2014/main" id="{C2DBA83E-C489-0E96-DABE-ED2E63091DE7}"/>
              </a:ext>
            </a:extLst>
          </p:cNvPr>
          <p:cNvSpPr>
            <a:spLocks noChangeArrowheads="1"/>
          </p:cNvSpPr>
          <p:nvPr/>
        </p:nvSpPr>
        <p:spPr bwMode="auto">
          <a:xfrm>
            <a:off x="1543803" y="5060142"/>
            <a:ext cx="6510537" cy="73866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indent="304800" algn="just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altLang="zh-CN" sz="1400" b="1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S</a:t>
            </a:r>
            <a:r>
              <a:rPr lang="en-US" altLang="zh-CN" sz="1400" b="1" bmk="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upplementary Figure 1.</a:t>
            </a:r>
            <a:r>
              <a:rPr lang="en-US" altLang="zh-CN" sz="1400" b="1" bmk="_Hlk167052555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altLang="zh-CN" sz="1400" bmk="_Hlk167052555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Number of differentially expressed genes (DEGs) compared between different samples.</a:t>
            </a:r>
            <a:r>
              <a:rPr lang="en-US" altLang="zh-CN" sz="1400" bmk="_Hlk167052555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altLang="zh-CN" sz="1400" bmk="_Hlk167052555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The red and blue columns represent up-regulated and down-regulated genes, respectively.</a:t>
            </a:r>
            <a:endParaRPr lang="en-US" altLang="zh-CN" sz="2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39398014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3</TotalTime>
  <Words>30</Words>
  <Application>Microsoft Office PowerPoint</Application>
  <PresentationFormat>全屏显示(4:3)</PresentationFormat>
  <Paragraphs>1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主题​​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靖欣 霍</dc:creator>
  <cp:lastModifiedBy>靖欣 霍</cp:lastModifiedBy>
  <cp:revision>1</cp:revision>
  <dcterms:created xsi:type="dcterms:W3CDTF">2024-05-29T17:14:03Z</dcterms:created>
  <dcterms:modified xsi:type="dcterms:W3CDTF">2024-05-29T17:17:20Z</dcterms:modified>
</cp:coreProperties>
</file>